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64" r:id="rId3"/>
    <p:sldId id="269" r:id="rId4"/>
    <p:sldId id="267" r:id="rId5"/>
    <p:sldId id="268" r:id="rId6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中度样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3C2FFA5D-87B4-456A-9821-1D502468CF0F}" styleName="主题样式 1 - 强调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99"/>
    <p:restoredTop sz="88526" autoAdjust="0"/>
  </p:normalViewPr>
  <p:slideViewPr>
    <p:cSldViewPr snapToGrid="0" snapToObjects="1">
      <p:cViewPr varScale="1">
        <p:scale>
          <a:sx n="100" d="100"/>
          <a:sy n="100" d="100"/>
        </p:scale>
        <p:origin x="1592" y="1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A7EAF-92AA-1944-AECD-DB89C6BCCA9D}" type="datetimeFigureOut">
              <a:rPr kumimoji="1" lang="zh-CN" altLang="en-US" smtClean="0"/>
              <a:t>2020/2/2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3F0FE-14E6-8145-AFAA-1EA320F7BDD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72660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A7EAF-92AA-1944-AECD-DB89C6BCCA9D}" type="datetimeFigureOut">
              <a:rPr kumimoji="1" lang="zh-CN" altLang="en-US" smtClean="0"/>
              <a:t>2020/2/2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3F0FE-14E6-8145-AFAA-1EA320F7BDD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90019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A7EAF-92AA-1944-AECD-DB89C6BCCA9D}" type="datetimeFigureOut">
              <a:rPr kumimoji="1" lang="zh-CN" altLang="en-US" smtClean="0"/>
              <a:t>2020/2/2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3F0FE-14E6-8145-AFAA-1EA320F7BDD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36491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A7EAF-92AA-1944-AECD-DB89C6BCCA9D}" type="datetimeFigureOut">
              <a:rPr kumimoji="1" lang="zh-CN" altLang="en-US" smtClean="0"/>
              <a:t>2020/2/2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3F0FE-14E6-8145-AFAA-1EA320F7BDD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838789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A7EAF-92AA-1944-AECD-DB89C6BCCA9D}" type="datetimeFigureOut">
              <a:rPr kumimoji="1" lang="zh-CN" altLang="en-US" smtClean="0"/>
              <a:t>2020/2/2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3F0FE-14E6-8145-AFAA-1EA320F7BDD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80168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A7EAF-92AA-1944-AECD-DB89C6BCCA9D}" type="datetimeFigureOut">
              <a:rPr kumimoji="1" lang="zh-CN" altLang="en-US" smtClean="0"/>
              <a:t>2020/2/2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3F0FE-14E6-8145-AFAA-1EA320F7BDD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514857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A7EAF-92AA-1944-AECD-DB89C6BCCA9D}" type="datetimeFigureOut">
              <a:rPr kumimoji="1" lang="zh-CN" altLang="en-US" smtClean="0"/>
              <a:t>2020/2/26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3F0FE-14E6-8145-AFAA-1EA320F7BDD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80925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A7EAF-92AA-1944-AECD-DB89C6BCCA9D}" type="datetimeFigureOut">
              <a:rPr kumimoji="1" lang="zh-CN" altLang="en-US" smtClean="0"/>
              <a:t>2020/2/26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3F0FE-14E6-8145-AFAA-1EA320F7BDD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456103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A7EAF-92AA-1944-AECD-DB89C6BCCA9D}" type="datetimeFigureOut">
              <a:rPr kumimoji="1" lang="zh-CN" altLang="en-US" smtClean="0"/>
              <a:t>2020/2/26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3F0FE-14E6-8145-AFAA-1EA320F7BDD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438243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A7EAF-92AA-1944-AECD-DB89C6BCCA9D}" type="datetimeFigureOut">
              <a:rPr kumimoji="1" lang="zh-CN" altLang="en-US" smtClean="0"/>
              <a:t>2020/2/2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3F0FE-14E6-8145-AFAA-1EA320F7BDD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44641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A7EAF-92AA-1944-AECD-DB89C6BCCA9D}" type="datetimeFigureOut">
              <a:rPr kumimoji="1" lang="zh-CN" altLang="en-US" smtClean="0"/>
              <a:t>2020/2/2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3F0FE-14E6-8145-AFAA-1EA320F7BDD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045431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DA7EAF-92AA-1944-AECD-DB89C6BCCA9D}" type="datetimeFigureOut">
              <a:rPr kumimoji="1" lang="zh-CN" altLang="en-US" smtClean="0"/>
              <a:t>2020/2/2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E3F0FE-14E6-8145-AFAA-1EA320F7BDD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084969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>
            <a:extLst>
              <a:ext uri="{FF2B5EF4-FFF2-40B4-BE49-F238E27FC236}">
                <a16:creationId xmlns:a16="http://schemas.microsoft.com/office/drawing/2014/main" id="{F28FC904-9447-5849-B6E3-8E3BD05EEE41}"/>
              </a:ext>
            </a:extLst>
          </p:cNvPr>
          <p:cNvSpPr/>
          <p:nvPr/>
        </p:nvSpPr>
        <p:spPr>
          <a:xfrm>
            <a:off x="481933" y="2173998"/>
            <a:ext cx="8146473" cy="3361492"/>
          </a:xfrm>
          <a:prstGeom prst="rect">
            <a:avLst/>
          </a:prstGeom>
        </p:spPr>
        <p:txBody>
          <a:bodyPr wrap="square"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Jing Cui</a:t>
            </a:r>
            <a:r>
              <a:rPr lang="en-US" kern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Ji Zhao</a:t>
            </a:r>
            <a:r>
              <a:rPr lang="en-US" altLang="zh-CN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2,3*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Zheng Wang</a:t>
            </a:r>
            <a:r>
              <a:rPr lang="en-US" altLang="zh-CN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Weiwei Cao</a:t>
            </a:r>
            <a:r>
              <a:rPr lang="en-US" altLang="zh-CN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dirty="0" err="1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haohua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Zhang</a:t>
            </a:r>
            <a:r>
              <a:rPr lang="zh-CN" altLang="en-US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，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Jumei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Liu</a:t>
            </a:r>
            <a:r>
              <a:rPr lang="en-US" altLang="zh-CN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dirty="0" err="1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Zhihua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Bao</a:t>
            </a:r>
            <a:r>
              <a:rPr lang="en-US" altLang="zh-CN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2,3*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</a:t>
            </a:r>
            <a:endParaRPr lang="en-US" i="1" kern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endParaRPr lang="en-US" i="1" kern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1 School of Life Sciences, Inner Mongolia University, Hohhot 010070, China</a:t>
            </a:r>
            <a:endParaRPr lang="zh-CN" kern="1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2 Ministry of Education Key Laboratory of Ecology and Resource Use of the Mongolian Plateau &amp; Inner Mongolia Key Laboratory of Grassland Ecology, School of Ecology and Environment, Inner Mongolia University, Hohhot, 010021, China</a:t>
            </a:r>
            <a:endParaRPr lang="zh-CN" kern="1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3 Inner Mongolia Key Laboratory of Environmental Pollution Control &amp; Waste Resource Reuse, Inner Mongolia University, Hohhot 010021, China</a:t>
            </a:r>
          </a:p>
          <a:p>
            <a:pPr algn="just">
              <a:spcAft>
                <a:spcPts val="0"/>
              </a:spcAft>
            </a:pPr>
            <a:r>
              <a:rPr lang="en-US" altLang="zh-CN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4 College of Chemistry and Environmental Engineering, Chongqing Key Laboratory of Environmental Materials &amp;Remediation Technologies, Chongqing University of Arts and Sciences, Chongqing, 402160, China. </a:t>
            </a:r>
            <a:endParaRPr lang="zh-CN" i="1" kern="1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3B392A36-69D1-9841-866C-F06F85382004}"/>
              </a:ext>
            </a:extLst>
          </p:cNvPr>
          <p:cNvSpPr/>
          <p:nvPr/>
        </p:nvSpPr>
        <p:spPr>
          <a:xfrm>
            <a:off x="674343" y="5695271"/>
            <a:ext cx="722392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sz="16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*Corresponding author: </a:t>
            </a:r>
            <a:r>
              <a:rPr lang="en-US" sz="16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Zhihua</a:t>
            </a:r>
            <a:r>
              <a:rPr lang="en-US" sz="16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Bao, Ji Zhao; School of Ecology and Environment, Inner Mongolia University, 235 West University Street, Hohhot 010021</a:t>
            </a:r>
            <a:r>
              <a:rPr lang="en-US" sz="16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sz="16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hina. Phone: +86-471-499-1469. E-mail: </a:t>
            </a:r>
            <a:r>
              <a:rPr lang="en-US" sz="16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zhihua_bao@imu.edu.cn</a:t>
            </a:r>
            <a:r>
              <a:rPr lang="en-US" sz="16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; </a:t>
            </a:r>
            <a:r>
              <a:rPr lang="en-US" sz="16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dzj@imu.edu.cn</a:t>
            </a:r>
            <a:r>
              <a:rPr lang="en-US" sz="16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sz="16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8ED03365-46F5-6E45-B54F-31947AA05825}"/>
              </a:ext>
            </a:extLst>
          </p:cNvPr>
          <p:cNvSpPr/>
          <p:nvPr/>
        </p:nvSpPr>
        <p:spPr>
          <a:xfrm>
            <a:off x="72654" y="609299"/>
            <a:ext cx="9001495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20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iversity of active root-associated methanotrophs of three emergent plants</a:t>
            </a:r>
            <a:r>
              <a:rPr lang="en-US" altLang="zh-CN" sz="2000" b="1" kern="100" dirty="0">
                <a:latin typeface="DengXian" panose="02010600030101010101" pitchFamily="2" charset="-122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20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 a eutrophic wetland in northern China</a:t>
            </a:r>
            <a:r>
              <a:rPr lang="en-US" altLang="zh-CN" sz="2000" b="1" kern="100" dirty="0">
                <a:latin typeface="DengXian" panose="02010600030101010101" pitchFamily="2" charset="-122"/>
                <a:ea typeface="DengXian" panose="02010600030101010101" pitchFamily="2" charset="-122"/>
                <a:cs typeface="Times New Roman" panose="02020603050405020304" pitchFamily="18" charset="0"/>
              </a:rPr>
              <a:t> </a:t>
            </a:r>
            <a:endParaRPr lang="zh-CN" altLang="zh-CN" sz="2000" b="1" kern="100" dirty="0"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5C9E853F-046D-4354-98B0-F7FC72684BA4}"/>
              </a:ext>
            </a:extLst>
          </p:cNvPr>
          <p:cNvSpPr txBox="1"/>
          <p:nvPr/>
        </p:nvSpPr>
        <p:spPr>
          <a:xfrm>
            <a:off x="3458633" y="1501205"/>
            <a:ext cx="24722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ry files</a:t>
            </a:r>
            <a:endParaRPr lang="zh-CN" altLang="en-US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C8DC5D5F-B332-3547-8889-E54E49C25749}"/>
              </a:ext>
            </a:extLst>
          </p:cNvPr>
          <p:cNvSpPr txBox="1"/>
          <p:nvPr/>
        </p:nvSpPr>
        <p:spPr>
          <a:xfrm>
            <a:off x="2334482" y="121172"/>
            <a:ext cx="51944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pplied Microbiology and Biotechnology </a:t>
            </a:r>
            <a:r>
              <a:rPr lang="en-US" altLang="zh-CN" dirty="0">
                <a:solidFill>
                  <a:srgbClr val="FF0000"/>
                </a:solidFill>
              </a:rPr>
              <a:t>Express</a:t>
            </a:r>
            <a:r>
              <a:rPr lang="zh-CN" altLang="zh-CN" dirty="0"/>
              <a:t> 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154058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4ED44F44-7714-45AB-AD19-38D04B744423}"/>
              </a:ext>
            </a:extLst>
          </p:cNvPr>
          <p:cNvSpPr txBox="1"/>
          <p:nvPr/>
        </p:nvSpPr>
        <p:spPr>
          <a:xfrm>
            <a:off x="932070" y="2504066"/>
            <a:ext cx="723900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Note: </a:t>
            </a: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Values are means ± standard errors (n=3).  </a:t>
            </a:r>
          </a:p>
          <a:p>
            <a:r>
              <a:rPr lang="en-US" altLang="zh-CN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: g/kg for TN,TP and TOC;</a:t>
            </a:r>
          </a:p>
          <a:p>
            <a:r>
              <a:rPr lang="en-US" altLang="zh-CN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: % for TN and TOC; mg/kg for TP</a:t>
            </a: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N, total nitrogen; TOC, total organic carbon; TP, total phosphorus; TK, total kalium; NH</a:t>
            </a:r>
            <a:r>
              <a:rPr lang="en-US" altLang="zh-CN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zh-CN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N, ammonium nitrogen; NO</a:t>
            </a:r>
            <a:r>
              <a:rPr lang="en-US" altLang="zh-CN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zh-CN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N, nitrate nitrogen; WC, water content</a:t>
            </a:r>
            <a:r>
              <a:rPr lang="en-US" altLang="zh-CN" sz="1000" dirty="0"/>
              <a:t>.</a:t>
            </a:r>
            <a:endParaRPr lang="zh-CN" altLang="en-US" sz="1000" dirty="0"/>
          </a:p>
        </p:txBody>
      </p:sp>
      <p:graphicFrame>
        <p:nvGraphicFramePr>
          <p:cNvPr id="3" name="表格 3">
            <a:extLst>
              <a:ext uri="{FF2B5EF4-FFF2-40B4-BE49-F238E27FC236}">
                <a16:creationId xmlns:a16="http://schemas.microsoft.com/office/drawing/2014/main" id="{3B3ADAC2-39B8-4236-9E59-E082BA04509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4350897"/>
              </p:ext>
            </p:extLst>
          </p:nvPr>
        </p:nvGraphicFramePr>
        <p:xfrm>
          <a:off x="932070" y="1865869"/>
          <a:ext cx="7620000" cy="55979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66825">
                  <a:extLst>
                    <a:ext uri="{9D8B030D-6E8A-4147-A177-3AD203B41FA5}">
                      <a16:colId xmlns:a16="http://schemas.microsoft.com/office/drawing/2014/main" val="638755010"/>
                    </a:ext>
                  </a:extLst>
                </a:gridCol>
                <a:gridCol w="847725">
                  <a:extLst>
                    <a:ext uri="{9D8B030D-6E8A-4147-A177-3AD203B41FA5}">
                      <a16:colId xmlns:a16="http://schemas.microsoft.com/office/drawing/2014/main" val="3367906887"/>
                    </a:ext>
                  </a:extLst>
                </a:gridCol>
                <a:gridCol w="819150">
                  <a:extLst>
                    <a:ext uri="{9D8B030D-6E8A-4147-A177-3AD203B41FA5}">
                      <a16:colId xmlns:a16="http://schemas.microsoft.com/office/drawing/2014/main" val="46332181"/>
                    </a:ext>
                  </a:extLst>
                </a:gridCol>
                <a:gridCol w="827666">
                  <a:extLst>
                    <a:ext uri="{9D8B030D-6E8A-4147-A177-3AD203B41FA5}">
                      <a16:colId xmlns:a16="http://schemas.microsoft.com/office/drawing/2014/main" val="4112954812"/>
                    </a:ext>
                  </a:extLst>
                </a:gridCol>
                <a:gridCol w="1077544">
                  <a:extLst>
                    <a:ext uri="{9D8B030D-6E8A-4147-A177-3AD203B41FA5}">
                      <a16:colId xmlns:a16="http://schemas.microsoft.com/office/drawing/2014/main" val="2895945548"/>
                    </a:ext>
                  </a:extLst>
                </a:gridCol>
                <a:gridCol w="952521">
                  <a:extLst>
                    <a:ext uri="{9D8B030D-6E8A-4147-A177-3AD203B41FA5}">
                      <a16:colId xmlns:a16="http://schemas.microsoft.com/office/drawing/2014/main" val="311974548"/>
                    </a:ext>
                  </a:extLst>
                </a:gridCol>
                <a:gridCol w="881589">
                  <a:extLst>
                    <a:ext uri="{9D8B030D-6E8A-4147-A177-3AD203B41FA5}">
                      <a16:colId xmlns:a16="http://schemas.microsoft.com/office/drawing/2014/main" val="1461328295"/>
                    </a:ext>
                  </a:extLst>
                </a:gridCol>
                <a:gridCol w="946980">
                  <a:extLst>
                    <a:ext uri="{9D8B030D-6E8A-4147-A177-3AD203B41FA5}">
                      <a16:colId xmlns:a16="http://schemas.microsoft.com/office/drawing/2014/main" val="4002337350"/>
                    </a:ext>
                  </a:extLst>
                </a:gridCol>
              </a:tblGrid>
              <a:tr h="2223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050" kern="100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N (%)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OC (%)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P (mg/kg)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H</a:t>
                      </a:r>
                      <a:r>
                        <a:rPr lang="en-US" altLang="zh-CN" sz="800" kern="100" baseline="-25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800" kern="100" baseline="5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N (mg/kg)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O</a:t>
                      </a:r>
                      <a:r>
                        <a:rPr lang="en-US" altLang="zh-CN" sz="800" kern="100" baseline="-25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800" kern="100" baseline="4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N (mg/kg)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WC (%)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H (H</a:t>
                      </a:r>
                      <a:r>
                        <a:rPr lang="en-US" sz="800" kern="100" baseline="-25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)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1261677"/>
                  </a:ext>
                </a:extLst>
              </a:tr>
              <a:tr h="30833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ediment </a:t>
                      </a:r>
                      <a:r>
                        <a:rPr lang="en-US" altLang="zh-CN" sz="800" kern="100" baseline="300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US" sz="800" kern="100" baseline="300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 </a:t>
                      </a:r>
                      <a:endParaRPr lang="zh-CN" sz="800" kern="100" baseline="300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.1±0.02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0.49±0.10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    0.38±0.00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1.71±0.5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.50±0.1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1.84±0.1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7.84±0.01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6960597"/>
                  </a:ext>
                </a:extLst>
              </a:tr>
            </a:tbl>
          </a:graphicData>
        </a:graphic>
      </p:graphicFrame>
      <p:sp>
        <p:nvSpPr>
          <p:cNvPr id="7" name="文本框 2">
            <a:extLst>
              <a:ext uri="{FF2B5EF4-FFF2-40B4-BE49-F238E27FC236}">
                <a16:creationId xmlns:a16="http://schemas.microsoft.com/office/drawing/2014/main" id="{0EBCA02F-CAA8-4CE0-A0D1-C131B12D11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21355" y="1338580"/>
            <a:ext cx="7241430" cy="4336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spcAft>
                <a:spcPts val="0"/>
              </a:spcAft>
            </a:pPr>
            <a:r>
              <a:rPr lang="en-US" sz="12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Table</a:t>
            </a:r>
            <a:r>
              <a:rPr lang="en-US" sz="1200" b="1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S1 </a:t>
            </a:r>
            <a:r>
              <a:rPr lang="en-US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physicochemical characteristics of </a:t>
            </a:r>
            <a:r>
              <a:rPr lang="en-US" altLang="zh-CN" sz="12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sediments and </a:t>
            </a:r>
            <a:r>
              <a:rPr lang="en-US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three plants roots in 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Wuliangsuhai</a:t>
            </a:r>
            <a:r>
              <a:rPr lang="en-US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wetland </a:t>
            </a:r>
            <a:endParaRPr lang="zh-CN" sz="1200" kern="100" dirty="0">
              <a:solidFill>
                <a:srgbClr val="FF0000"/>
              </a:solidFill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38349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2">
            <a:extLst>
              <a:ext uri="{FF2B5EF4-FFF2-40B4-BE49-F238E27FC236}">
                <a16:creationId xmlns:a16="http://schemas.microsoft.com/office/drawing/2014/main" id="{8B147D86-5F91-46F1-B667-5C1ED9499B5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3525" y="242887"/>
            <a:ext cx="6076950" cy="295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12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able.S</a:t>
            </a:r>
            <a:r>
              <a:rPr lang="en-US" altLang="zh-CN" sz="1200" b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he most closely related </a:t>
            </a:r>
            <a:r>
              <a:rPr lang="en-US" sz="1200" i="1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mo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sequences of OUTs in phylogenetic tree</a:t>
            </a:r>
            <a:endParaRPr 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>
              <a:spcAft>
                <a:spcPts val="0"/>
              </a:spcAft>
            </a:pPr>
            <a:r>
              <a:rPr lang="en-US" sz="105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 </a:t>
            </a:r>
            <a:endParaRPr lang="zh-CN" sz="105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771F4A76-9145-4BB8-80FE-DCE8B3118CAD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3732764600"/>
              </p:ext>
            </p:extLst>
          </p:nvPr>
        </p:nvGraphicFramePr>
        <p:xfrm>
          <a:off x="699911" y="572671"/>
          <a:ext cx="7992533" cy="5245099"/>
        </p:xfrm>
        <a:graphic>
          <a:graphicData uri="http://schemas.openxmlformats.org/drawingml/2006/table">
            <a:tbl>
              <a:tblPr firstRow="1" firstCol="1" bandRow="1"/>
              <a:tblGrid>
                <a:gridCol w="635757">
                  <a:extLst>
                    <a:ext uri="{9D8B030D-6E8A-4147-A177-3AD203B41FA5}">
                      <a16:colId xmlns:a16="http://schemas.microsoft.com/office/drawing/2014/main" val="3001926963"/>
                    </a:ext>
                  </a:extLst>
                </a:gridCol>
                <a:gridCol w="3010453">
                  <a:extLst>
                    <a:ext uri="{9D8B030D-6E8A-4147-A177-3AD203B41FA5}">
                      <a16:colId xmlns:a16="http://schemas.microsoft.com/office/drawing/2014/main" val="77277414"/>
                    </a:ext>
                  </a:extLst>
                </a:gridCol>
                <a:gridCol w="2622314">
                  <a:extLst>
                    <a:ext uri="{9D8B030D-6E8A-4147-A177-3AD203B41FA5}">
                      <a16:colId xmlns:a16="http://schemas.microsoft.com/office/drawing/2014/main" val="1254442825"/>
                    </a:ext>
                  </a:extLst>
                </a:gridCol>
                <a:gridCol w="1724009">
                  <a:extLst>
                    <a:ext uri="{9D8B030D-6E8A-4147-A177-3AD203B41FA5}">
                      <a16:colId xmlns:a16="http://schemas.microsoft.com/office/drawing/2014/main" val="33255202"/>
                    </a:ext>
                  </a:extLst>
                </a:gridCol>
              </a:tblGrid>
              <a:tr h="18043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s</a:t>
                      </a:r>
                      <a:endParaRPr lang="zh-CN" sz="1000" kern="100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1036" marR="6103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lative</a:t>
                      </a:r>
                      <a:endParaRPr lang="zh-CN" sz="1000" kern="100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1036" marR="6103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ccession No.</a:t>
                      </a:r>
                      <a:endParaRPr lang="zh-CN" sz="1000" kern="100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1036" marR="6103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dentity(%)</a:t>
                      </a:r>
                      <a:endParaRPr lang="zh-CN" sz="1000" kern="100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1036" marR="6103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575095"/>
                  </a:ext>
                </a:extLst>
              </a:tr>
              <a:tr h="506466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1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2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3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4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5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6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7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8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9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10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11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12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13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14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15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16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17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18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19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20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21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22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23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tu24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tu25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tu26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tu27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tu28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tu29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tu30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tu31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tu32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tu33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tu34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tu35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tu36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tu37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tu38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tu39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tu40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tu41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1036" marR="6103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ncultured </a:t>
                      </a:r>
                      <a:r>
                        <a:rPr lang="en-US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ethylobacter</a:t>
                      </a: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p.AFG24218.1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ncultured </a:t>
                      </a:r>
                      <a:r>
                        <a:rPr lang="en-US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ethylobacter</a:t>
                      </a: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p.E76</a:t>
                      </a:r>
                      <a:endParaRPr 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ethylovulum</a:t>
                      </a: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iyakonense</a:t>
                      </a:r>
                      <a:endParaRPr 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ncultured methanotrophic bacterium.P6-10-19</a:t>
                      </a:r>
                      <a:endParaRPr 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ncultured </a:t>
                      </a:r>
                      <a:r>
                        <a:rPr lang="en-US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ethylobacter</a:t>
                      </a: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p.Xh_pmoA_PA86</a:t>
                      </a:r>
                      <a:endParaRPr 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ncultured </a:t>
                      </a:r>
                      <a:r>
                        <a:rPr lang="en-US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ethylobacter</a:t>
                      </a: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p.C11-14</a:t>
                      </a:r>
                      <a:endParaRPr 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ethylocucumis</a:t>
                      </a: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ryzae</a:t>
                      </a:r>
                      <a:endParaRPr 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ncultured methanotrophic bacterium.F442</a:t>
                      </a:r>
                      <a:endParaRPr 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ethylobacter</a:t>
                      </a: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p. KRF1</a:t>
                      </a:r>
                      <a:endParaRPr 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ncultured methanotrophic bacterium.F48</a:t>
                      </a:r>
                      <a:endParaRPr 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ncultured </a:t>
                      </a:r>
                      <a:r>
                        <a:rPr lang="en-US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ethylobacter</a:t>
                      </a: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p.</a:t>
                      </a:r>
                      <a:endParaRPr 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ethylomicrobium</a:t>
                      </a: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p.RSKB-5</a:t>
                      </a:r>
                      <a:endParaRPr 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ethylomonas sp.</a:t>
                      </a:r>
                      <a:endParaRPr 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ethyloglobulus</a:t>
                      </a: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orosus</a:t>
                      </a:r>
                      <a:endParaRPr 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i="1" kern="100" dirty="0" err="1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ethylomonas</a:t>
                      </a:r>
                      <a:r>
                        <a:rPr lang="en-US" sz="800" i="1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p. LW13</a:t>
                      </a:r>
                      <a:endParaRPr lang="zh-CN" sz="800" i="1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ethylomonas sp. D1a</a:t>
                      </a:r>
                      <a:endParaRPr 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ncultured </a:t>
                      </a:r>
                      <a:r>
                        <a:rPr lang="en-US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ethylococcaceae</a:t>
                      </a: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pmo-F8</a:t>
                      </a:r>
                      <a:endParaRPr 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ncultured bacterium FW-50</a:t>
                      </a:r>
                      <a:endParaRPr 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ethylomagnum</a:t>
                      </a: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shizawai</a:t>
                      </a:r>
                      <a:endParaRPr 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ncultured Methylocystis sp.SJ-mb661-CL5</a:t>
                      </a:r>
                      <a:endParaRPr 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ethylocystis </a:t>
                      </a:r>
                      <a:r>
                        <a:rPr lang="en-US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irsuta</a:t>
                      </a:r>
                      <a:endParaRPr lang="en-US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hylobacter</a:t>
                      </a: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luteus</a:t>
                      </a:r>
                      <a:endParaRPr lang="zh-CN" alt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hylomicrobium</a:t>
                      </a: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zh-CN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uryatense</a:t>
                      </a: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endParaRPr lang="zh-CN" alt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ncultured bacterium PS-49</a:t>
                      </a:r>
                      <a:endParaRPr lang="zh-CN" alt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ncultured methanotrophic bacterium.F48</a:t>
                      </a:r>
                      <a:endParaRPr lang="zh-CN" alt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ncultured </a:t>
                      </a:r>
                      <a:r>
                        <a:rPr lang="en-US" altLang="zh-CN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hylocaldum</a:t>
                      </a: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sp. N63</a:t>
                      </a:r>
                      <a:endParaRPr lang="zh-CN" alt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hylomicrobium</a:t>
                      </a: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sp. wino1</a:t>
                      </a:r>
                      <a:endParaRPr lang="zh-CN" alt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ncultured Methylomonas sp. DR10pmo</a:t>
                      </a:r>
                      <a:endParaRPr lang="zh-CN" alt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ncultured </a:t>
                      </a:r>
                      <a:r>
                        <a:rPr lang="en-US" altLang="zh-CN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hylobacter</a:t>
                      </a: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sp. Xh_pmoA_PA59</a:t>
                      </a:r>
                      <a:endParaRPr lang="zh-CN" alt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hylobacter</a:t>
                      </a: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sp.</a:t>
                      </a:r>
                      <a:endParaRPr lang="zh-CN" alt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ncultured </a:t>
                      </a:r>
                      <a:r>
                        <a:rPr lang="en-US" altLang="zh-CN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hylobacter</a:t>
                      </a: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sp. 13RH2Omb19</a:t>
                      </a:r>
                      <a:endParaRPr lang="zh-CN" alt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ncultured </a:t>
                      </a:r>
                      <a:r>
                        <a:rPr lang="en-US" altLang="zh-CN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hylosarcina</a:t>
                      </a: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sp. Xh_pmoA_TO67</a:t>
                      </a:r>
                      <a:endParaRPr lang="zh-CN" alt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ncultured Methylosinus sp. KF31-1</a:t>
                      </a:r>
                      <a:endParaRPr lang="zh-CN" alt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hylomicrobium</a:t>
                      </a: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sp. wino1</a:t>
                      </a:r>
                      <a:endParaRPr lang="zh-CN" alt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ncultured bacterium WC306-17</a:t>
                      </a:r>
                      <a:endParaRPr lang="zh-CN" alt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hylomonas sp.</a:t>
                      </a:r>
                      <a:endParaRPr lang="zh-CN" alt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ncultured </a:t>
                      </a:r>
                      <a:r>
                        <a:rPr lang="en-US" altLang="zh-CN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hylobacter</a:t>
                      </a: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sp. Xh_pmoA_PA50</a:t>
                      </a:r>
                      <a:endParaRPr lang="zh-CN" alt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hylotetracoccus</a:t>
                      </a: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zh-CN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ryzae</a:t>
                      </a:r>
                      <a:endParaRPr lang="zh-CN" alt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hylomonas</a:t>
                      </a: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paludism</a:t>
                      </a:r>
                      <a:endParaRPr lang="zh-CN" alt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ncultured bacterium.LL_C1_G12</a:t>
                      </a:r>
                      <a:endParaRPr lang="zh-CN" alt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hylovulum</a:t>
                      </a:r>
                      <a:r>
                        <a:rPr lang="en-US" altLang="zh-CN" sz="8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zh-CN" sz="8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iyakonense</a:t>
                      </a:r>
                      <a:endParaRPr lang="zh-CN" altLang="zh-CN" sz="8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1036" marR="6103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FG24218.1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EL33669.1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WP_019865090.1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FP86126.1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FG24228.1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CV82273.1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WP_045780347.1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DM12732.1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WP_127027946.1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DM12736.1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EL33669.1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NC90374.1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QBB78506.1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CE95875.1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dirty="0">
                          <a:solidFill>
                            <a:srgbClr val="FF0000"/>
                          </a:solidFill>
                        </a:rPr>
                        <a:t>WP_033159227.1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AD66437.1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CE95876.1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AF64106.1</a:t>
                      </a:r>
                      <a:endParaRPr 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WP_085214205.1 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HH01476.1 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WP_123175059.1 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P_027159170.1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P_017841993.1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AF64098.1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DM12736.1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LF41050.1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P_125218080.1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AI22748.1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FG24215.1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QBF67875.1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BU98407.1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FG24234.1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AM37123.1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P_125218080.1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AF64100.1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TA58053.1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FG24221.1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P_129883941.1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CH22593.1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FG24234.1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P_019865090.1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1036" marR="6103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0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0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7.45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2.36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8.99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0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0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0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9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7.98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0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6.97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0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0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0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0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0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9.36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4.90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0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0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4.27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6.82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8.73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6.71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6.18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0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0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0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0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7.98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0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8.73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8.73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9.36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7.45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3.63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8.09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1.08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9.36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9.36</a:t>
                      </a:r>
                      <a:endParaRPr lang="zh-CN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1036" marR="6103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158921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384848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893D4368-DE74-4340-8208-5ADF02E79356}"/>
              </a:ext>
            </a:extLst>
          </p:cNvPr>
          <p:cNvGrpSpPr/>
          <p:nvPr/>
        </p:nvGrpSpPr>
        <p:grpSpPr>
          <a:xfrm>
            <a:off x="466566" y="942340"/>
            <a:ext cx="4352925" cy="4339590"/>
            <a:chOff x="0" y="0"/>
            <a:chExt cx="4352925" cy="4339590"/>
          </a:xfrm>
        </p:grpSpPr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EFCA1CF1-E825-4B86-9E57-0C0F626DDEE2}"/>
                </a:ext>
              </a:extLst>
            </p:cNvPr>
            <p:cNvGrpSpPr/>
            <p:nvPr/>
          </p:nvGrpSpPr>
          <p:grpSpPr>
            <a:xfrm>
              <a:off x="0" y="0"/>
              <a:ext cx="4352925" cy="4339590"/>
              <a:chOff x="0" y="0"/>
              <a:chExt cx="4352925" cy="4339590"/>
            </a:xfrm>
          </p:grpSpPr>
          <p:grpSp>
            <p:nvGrpSpPr>
              <p:cNvPr id="5" name="组合 4">
                <a:extLst>
                  <a:ext uri="{FF2B5EF4-FFF2-40B4-BE49-F238E27FC236}">
                    <a16:creationId xmlns:a16="http://schemas.microsoft.com/office/drawing/2014/main" id="{66C5525A-A1EA-4AF5-A85D-AC7E9296AAD8}"/>
                  </a:ext>
                </a:extLst>
              </p:cNvPr>
              <p:cNvGrpSpPr/>
              <p:nvPr/>
            </p:nvGrpSpPr>
            <p:grpSpPr>
              <a:xfrm>
                <a:off x="0" y="0"/>
                <a:ext cx="4352925" cy="4267200"/>
                <a:chOff x="0" y="0"/>
                <a:chExt cx="4352925" cy="4267200"/>
              </a:xfrm>
            </p:grpSpPr>
            <p:pic>
              <p:nvPicPr>
                <p:cNvPr id="7" name="图片 6">
                  <a:extLst>
                    <a:ext uri="{FF2B5EF4-FFF2-40B4-BE49-F238E27FC236}">
                      <a16:creationId xmlns:a16="http://schemas.microsoft.com/office/drawing/2014/main" id="{7E4FEC10-D2AD-4E57-961F-C4F503D905E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0" y="0"/>
                  <a:ext cx="4352925" cy="4267200"/>
                </a:xfrm>
                <a:prstGeom prst="rect">
                  <a:avLst/>
                </a:prstGeom>
                <a:noFill/>
              </p:spPr>
            </p:pic>
            <p:sp>
              <p:nvSpPr>
                <p:cNvPr id="8" name="文本框 2">
                  <a:extLst>
                    <a:ext uri="{FF2B5EF4-FFF2-40B4-BE49-F238E27FC236}">
                      <a16:creationId xmlns:a16="http://schemas.microsoft.com/office/drawing/2014/main" id="{6FF6FF68-227E-4A5E-B6B9-D3D411303F3B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62000" y="3752850"/>
                  <a:ext cx="3450990" cy="298450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algn="just">
                    <a:spcAft>
                      <a:spcPts val="0"/>
                    </a:spcAft>
                  </a:pPr>
                  <a:r>
                    <a:rPr lang="en-US" sz="900" kern="100" dirty="0">
                      <a:effectLst/>
                      <a:latin typeface="Arial" panose="020B0604020202020204" pitchFamily="34" charset="0"/>
                      <a:ea typeface="等线" panose="02010600030101010101" pitchFamily="2" charset="-122"/>
                      <a:cs typeface="Times New Roman" panose="02020603050405020304" pitchFamily="18" charset="0"/>
                    </a:rPr>
                    <a:t>PAR           STR          TAR         PAR           STR         TAR</a:t>
                  </a:r>
                  <a:endParaRPr lang="zh-CN" sz="1050" kern="100" dirty="0">
                    <a:effectLst/>
                    <a:latin typeface="等线" panose="02010600030101010101" pitchFamily="2" charset="-122"/>
                    <a:ea typeface="等线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171B8FFE-1E72-4B6E-A12D-9E780DC5E360}"/>
                  </a:ext>
                </a:extLst>
              </p:cNvPr>
              <p:cNvSpPr txBox="1"/>
              <p:nvPr/>
            </p:nvSpPr>
            <p:spPr>
              <a:xfrm>
                <a:off x="1098550" y="4000500"/>
                <a:ext cx="2305050" cy="33909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noAutofit/>
              </a:bodyPr>
              <a:lstStyle/>
              <a:p>
                <a:pPr algn="just">
                  <a:spcAft>
                    <a:spcPts val="0"/>
                  </a:spcAft>
                </a:pPr>
                <a:r>
                  <a:rPr lang="en-US" sz="1100" kern="1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    DNA                                  cDNA</a:t>
                </a:r>
                <a:endParaRPr lang="zh-CN" sz="1050" kern="100" dirty="0">
                  <a:effectLst/>
                  <a:latin typeface="等线" panose="02010600030101010101" pitchFamily="2" charset="-122"/>
                  <a:ea typeface="等线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" name="文本框 2">
              <a:extLst>
                <a:ext uri="{FF2B5EF4-FFF2-40B4-BE49-F238E27FC236}">
                  <a16:creationId xmlns:a16="http://schemas.microsoft.com/office/drawing/2014/main" id="{F8E2FEE3-BA54-4E39-BDBA-81D6AFE8294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304165" y="1772285"/>
              <a:ext cx="858202" cy="245112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1200" kern="100" dirty="0"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C</a:t>
              </a:r>
              <a:r>
                <a:rPr lang="en-US" sz="1200" kern="100" dirty="0"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hao</a:t>
              </a:r>
              <a:endParaRPr lang="zh-CN" sz="1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" name="组合 8">
            <a:extLst>
              <a:ext uri="{FF2B5EF4-FFF2-40B4-BE49-F238E27FC236}">
                <a16:creationId xmlns:a16="http://schemas.microsoft.com/office/drawing/2014/main" id="{950B8598-10BB-4131-9C5B-6A5A1C9221B1}"/>
              </a:ext>
            </a:extLst>
          </p:cNvPr>
          <p:cNvGrpSpPr/>
          <p:nvPr/>
        </p:nvGrpSpPr>
        <p:grpSpPr>
          <a:xfrm>
            <a:off x="4597035" y="1362834"/>
            <a:ext cx="4162900" cy="3617863"/>
            <a:chOff x="25856" y="12672"/>
            <a:chExt cx="4299266" cy="3610003"/>
          </a:xfrm>
        </p:grpSpPr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5D2C2505-A39A-4D75-B9E1-AB3A6A24950F}"/>
                </a:ext>
              </a:extLst>
            </p:cNvPr>
            <p:cNvGrpSpPr/>
            <p:nvPr/>
          </p:nvGrpSpPr>
          <p:grpSpPr>
            <a:xfrm>
              <a:off x="25856" y="12672"/>
              <a:ext cx="4299266" cy="3610003"/>
              <a:chOff x="25856" y="12672"/>
              <a:chExt cx="4299266" cy="3610003"/>
            </a:xfrm>
          </p:grpSpPr>
          <p:grpSp>
            <p:nvGrpSpPr>
              <p:cNvPr id="14" name="组合 13">
                <a:extLst>
                  <a:ext uri="{FF2B5EF4-FFF2-40B4-BE49-F238E27FC236}">
                    <a16:creationId xmlns:a16="http://schemas.microsoft.com/office/drawing/2014/main" id="{457E1BC1-CA53-45EE-8F6F-5CFDAF5271C7}"/>
                  </a:ext>
                </a:extLst>
              </p:cNvPr>
              <p:cNvGrpSpPr/>
              <p:nvPr/>
            </p:nvGrpSpPr>
            <p:grpSpPr>
              <a:xfrm>
                <a:off x="97790" y="12672"/>
                <a:ext cx="4227332" cy="3610003"/>
                <a:chOff x="0" y="12672"/>
                <a:chExt cx="4227332" cy="3610003"/>
              </a:xfrm>
            </p:grpSpPr>
            <p:pic>
              <p:nvPicPr>
                <p:cNvPr id="16" name="图片 15">
                  <a:extLst>
                    <a:ext uri="{FF2B5EF4-FFF2-40B4-BE49-F238E27FC236}">
                      <a16:creationId xmlns:a16="http://schemas.microsoft.com/office/drawing/2014/main" id="{0B0713D9-66E2-43C1-A7B6-CACBC4FA145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5389"/>
                <a:stretch/>
              </p:blipFill>
              <p:spPr>
                <a:xfrm>
                  <a:off x="0" y="12672"/>
                  <a:ext cx="4227332" cy="3525340"/>
                </a:xfrm>
                <a:prstGeom prst="rect">
                  <a:avLst/>
                </a:prstGeom>
              </p:spPr>
            </p:pic>
            <p:sp>
              <p:nvSpPr>
                <p:cNvPr id="17" name="文本框 2">
                  <a:extLst>
                    <a:ext uri="{FF2B5EF4-FFF2-40B4-BE49-F238E27FC236}">
                      <a16:creationId xmlns:a16="http://schemas.microsoft.com/office/drawing/2014/main" id="{1726F018-152B-4932-8DC7-0482B8F7B2C7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52467" y="3324225"/>
                  <a:ext cx="3474865" cy="298450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algn="just">
                    <a:spcAft>
                      <a:spcPts val="0"/>
                    </a:spcAft>
                  </a:pPr>
                  <a:r>
                    <a:rPr lang="en-US" sz="900" kern="100" dirty="0">
                      <a:effectLst/>
                      <a:latin typeface="Arial" panose="020B0604020202020204" pitchFamily="34" charset="0"/>
                      <a:ea typeface="等线" panose="02010600030101010101" pitchFamily="2" charset="-122"/>
                      <a:cs typeface="Times New Roman" panose="02020603050405020304" pitchFamily="18" charset="0"/>
                    </a:rPr>
                    <a:t>PAR         STR          TAR           PAR          STR          TAR</a:t>
                  </a:r>
                  <a:endParaRPr lang="zh-CN" sz="1050" kern="100" dirty="0">
                    <a:effectLst/>
                    <a:latin typeface="等线" panose="02010600030101010101" pitchFamily="2" charset="-122"/>
                    <a:ea typeface="等线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5" name="文本框 2">
                <a:extLst>
                  <a:ext uri="{FF2B5EF4-FFF2-40B4-BE49-F238E27FC236}">
                    <a16:creationId xmlns:a16="http://schemas.microsoft.com/office/drawing/2014/main" id="{8DB16BAD-D8C0-43C7-B97C-1BA14A7D04C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-292914" y="1345045"/>
                <a:ext cx="934720" cy="297180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 algn="just">
                  <a:spcAft>
                    <a:spcPts val="0"/>
                  </a:spcAft>
                </a:pPr>
                <a:r>
                  <a:rPr lang="en-US" sz="1200" kern="100" dirty="0">
                    <a:latin typeface="Arial" panose="020B0604020202020204" pitchFamily="34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S</a:t>
                </a:r>
                <a:r>
                  <a:rPr lang="en-US" sz="1200" kern="1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impson</a:t>
                </a:r>
                <a:endParaRPr lang="zh-CN" sz="1200" kern="100" dirty="0">
                  <a:effectLst/>
                  <a:latin typeface="等线" panose="02010600030101010101" pitchFamily="2" charset="-122"/>
                  <a:ea typeface="等线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" name="组合 10">
              <a:extLst>
                <a:ext uri="{FF2B5EF4-FFF2-40B4-BE49-F238E27FC236}">
                  <a16:creationId xmlns:a16="http://schemas.microsoft.com/office/drawing/2014/main" id="{69407879-339F-48F3-9411-4A0F963A964A}"/>
                </a:ext>
              </a:extLst>
            </p:cNvPr>
            <p:cNvGrpSpPr/>
            <p:nvPr/>
          </p:nvGrpSpPr>
          <p:grpSpPr>
            <a:xfrm>
              <a:off x="971550" y="3572464"/>
              <a:ext cx="2972271" cy="3423"/>
              <a:chOff x="0" y="-75611"/>
              <a:chExt cx="2972271" cy="3423"/>
            </a:xfrm>
          </p:grpSpPr>
          <p:cxnSp>
            <p:nvCxnSpPr>
              <p:cNvPr id="12" name="直接连接符 11">
                <a:extLst>
                  <a:ext uri="{FF2B5EF4-FFF2-40B4-BE49-F238E27FC236}">
                    <a16:creationId xmlns:a16="http://schemas.microsoft.com/office/drawing/2014/main" id="{264CE86F-2033-4144-91B5-8BBF878CE5A2}"/>
                  </a:ext>
                </a:extLst>
              </p:cNvPr>
              <p:cNvCxnSpPr/>
              <p:nvPr/>
            </p:nvCxnSpPr>
            <p:spPr>
              <a:xfrm>
                <a:off x="0" y="-72188"/>
                <a:ext cx="1266825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" name="直接连接符 12">
                <a:extLst>
                  <a:ext uri="{FF2B5EF4-FFF2-40B4-BE49-F238E27FC236}">
                    <a16:creationId xmlns:a16="http://schemas.microsoft.com/office/drawing/2014/main" id="{CF5EF93E-B47D-41DF-A9AA-6A0BEA2910EC}"/>
                  </a:ext>
                </a:extLst>
              </p:cNvPr>
              <p:cNvCxnSpPr/>
              <p:nvPr/>
            </p:nvCxnSpPr>
            <p:spPr>
              <a:xfrm>
                <a:off x="1705446" y="-75611"/>
                <a:ext cx="1266825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18" name="文本框 5">
            <a:extLst>
              <a:ext uri="{FF2B5EF4-FFF2-40B4-BE49-F238E27FC236}">
                <a16:creationId xmlns:a16="http://schemas.microsoft.com/office/drawing/2014/main" id="{4B4116B5-FC57-40F1-8A5A-C51D99D78E0B}"/>
              </a:ext>
            </a:extLst>
          </p:cNvPr>
          <p:cNvSpPr txBox="1"/>
          <p:nvPr/>
        </p:nvSpPr>
        <p:spPr>
          <a:xfrm>
            <a:off x="5925086" y="4930775"/>
            <a:ext cx="2305050" cy="3390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sz="11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DNA                                  cDNA</a:t>
            </a:r>
            <a:endParaRPr lang="zh-CN" sz="105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ABDA1ABD-F9A7-4D44-ABA2-DEE05BB4FC1F}"/>
              </a:ext>
            </a:extLst>
          </p:cNvPr>
          <p:cNvCxnSpPr/>
          <p:nvPr/>
        </p:nvCxnSpPr>
        <p:spPr>
          <a:xfrm>
            <a:off x="1337363" y="4944443"/>
            <a:ext cx="122664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C342251D-29F2-4C8B-B858-98ED97D84AAC}"/>
              </a:ext>
            </a:extLst>
          </p:cNvPr>
          <p:cNvCxnSpPr/>
          <p:nvPr/>
        </p:nvCxnSpPr>
        <p:spPr>
          <a:xfrm>
            <a:off x="2954061" y="4944443"/>
            <a:ext cx="122664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">
            <a:extLst>
              <a:ext uri="{FF2B5EF4-FFF2-40B4-BE49-F238E27FC236}">
                <a16:creationId xmlns:a16="http://schemas.microsoft.com/office/drawing/2014/main" id="{5BAD7087-90B8-479A-A5DB-0788A48005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7400" y="5367878"/>
            <a:ext cx="7861300" cy="11638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r>
              <a:rPr lang="en-US" sz="12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.S1</a:t>
            </a:r>
            <a:r>
              <a:rPr lang="en-US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200" kern="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lpha diversity of aerobic methanotroph calculation based on</a:t>
            </a:r>
            <a:r>
              <a:rPr lang="en-US" sz="1200" i="1" kern="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200" i="1" kern="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mo</a:t>
            </a:r>
            <a:r>
              <a:rPr lang="en-US" sz="1200" kern="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sz="1200" kern="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. The OTUs richness and OTUs evenness of root microbiotas is shown by chao(a) and Simpson index (b).</a:t>
            </a:r>
            <a:r>
              <a:rPr lang="en-US" sz="1200" kern="100" dirty="0">
                <a:solidFill>
                  <a:srgbClr val="4A90E2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200" kern="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he red boxplot based on DNA; the green boxplot based on cDNA.</a:t>
            </a:r>
            <a:r>
              <a:rPr lang="en-US" sz="1200" kern="0" dirty="0">
                <a:solidFill>
                  <a:srgbClr val="131413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200" kern="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Error bars </a:t>
            </a:r>
            <a:r>
              <a:rPr lang="en-US" sz="1200" kern="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epresent the standard error of the mean. Asterisks denote statistically significant differences between samples (**p &lt; 0.01</a:t>
            </a:r>
            <a:r>
              <a:rPr lang="en-US" sz="1200" kern="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*p &lt; 0.05)</a:t>
            </a:r>
            <a:r>
              <a:rPr lang="en-US" sz="1200" kern="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.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kern="0" dirty="0">
                <a:solidFill>
                  <a:srgbClr val="FF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ars with the different letter (a, b or c) within a panel are significantly different between groups(p&lt;0.05)</a:t>
            </a:r>
            <a:endParaRPr lang="zh-CN" altLang="en-US" sz="1200" kern="0" dirty="0">
              <a:solidFill>
                <a:srgbClr val="FF0000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>
              <a:spcAft>
                <a:spcPts val="0"/>
              </a:spcAft>
            </a:pPr>
            <a:r>
              <a:rPr lang="en-US" sz="105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 </a:t>
            </a:r>
            <a:endParaRPr lang="zh-CN" sz="105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A290CA2E-CC47-7E4F-9135-BB496F54BB81}"/>
              </a:ext>
            </a:extLst>
          </p:cNvPr>
          <p:cNvSpPr/>
          <p:nvPr/>
        </p:nvSpPr>
        <p:spPr>
          <a:xfrm>
            <a:off x="2954061" y="1612900"/>
            <a:ext cx="1226643" cy="3937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82FC02AE-9E9C-8D42-A3B0-E08F36185AC3}"/>
              </a:ext>
            </a:extLst>
          </p:cNvPr>
          <p:cNvSpPr txBox="1"/>
          <p:nvPr/>
        </p:nvSpPr>
        <p:spPr>
          <a:xfrm>
            <a:off x="2915961" y="1780643"/>
            <a:ext cx="2844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9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zh-CN" altLang="en-US" sz="9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EA3A1AA8-C575-984A-8247-59FA78957E79}"/>
              </a:ext>
            </a:extLst>
          </p:cNvPr>
          <p:cNvSpPr txBox="1"/>
          <p:nvPr/>
        </p:nvSpPr>
        <p:spPr>
          <a:xfrm>
            <a:off x="3459081" y="2956749"/>
            <a:ext cx="2844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9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CN" altLang="en-US" sz="9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34315106-3141-6943-A4F8-D6F1995F8993}"/>
              </a:ext>
            </a:extLst>
          </p:cNvPr>
          <p:cNvSpPr txBox="1"/>
          <p:nvPr/>
        </p:nvSpPr>
        <p:spPr>
          <a:xfrm>
            <a:off x="3991514" y="2641533"/>
            <a:ext cx="3783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9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kumimoji="1" lang="zh-CN" altLang="en-US" sz="9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99DE02C3-BE9D-954A-BE12-118CF78346B0}"/>
              </a:ext>
            </a:extLst>
          </p:cNvPr>
          <p:cNvSpPr txBox="1"/>
          <p:nvPr/>
        </p:nvSpPr>
        <p:spPr>
          <a:xfrm>
            <a:off x="5430261" y="3077627"/>
            <a:ext cx="2844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9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zh-CN" altLang="en-US" sz="9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B17B9C48-C13D-364D-8217-EE5831221D9B}"/>
              </a:ext>
            </a:extLst>
          </p:cNvPr>
          <p:cNvSpPr/>
          <p:nvPr/>
        </p:nvSpPr>
        <p:spPr>
          <a:xfrm>
            <a:off x="5442272" y="1867191"/>
            <a:ext cx="1226643" cy="65350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CCA0FF13-D164-A24A-9A94-277F64355D3F}"/>
              </a:ext>
            </a:extLst>
          </p:cNvPr>
          <p:cNvSpPr txBox="1"/>
          <p:nvPr/>
        </p:nvSpPr>
        <p:spPr>
          <a:xfrm>
            <a:off x="5992219" y="2301898"/>
            <a:ext cx="2844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9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CN" altLang="en-US" sz="9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EB7890A-58CD-8D46-B355-6609859DF9EB}"/>
              </a:ext>
            </a:extLst>
          </p:cNvPr>
          <p:cNvSpPr txBox="1"/>
          <p:nvPr/>
        </p:nvSpPr>
        <p:spPr>
          <a:xfrm>
            <a:off x="6534787" y="2470758"/>
            <a:ext cx="3783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9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zh-CN" altLang="en-US" sz="9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EF2EB96B-B9B5-D64B-ADE9-8EABC0EE95CB}"/>
              </a:ext>
            </a:extLst>
          </p:cNvPr>
          <p:cNvSpPr txBox="1"/>
          <p:nvPr/>
        </p:nvSpPr>
        <p:spPr>
          <a:xfrm>
            <a:off x="7083799" y="3523135"/>
            <a:ext cx="2844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9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zh-CN" altLang="en-US" sz="9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C1C564DE-21D6-4F44-840B-9DA2C747F02F}"/>
              </a:ext>
            </a:extLst>
          </p:cNvPr>
          <p:cNvSpPr txBox="1"/>
          <p:nvPr/>
        </p:nvSpPr>
        <p:spPr>
          <a:xfrm>
            <a:off x="8201409" y="3702372"/>
            <a:ext cx="3783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9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zh-CN" altLang="en-US" sz="9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A4349419-E97D-DD45-B5B2-2EBFB5117ABC}"/>
              </a:ext>
            </a:extLst>
          </p:cNvPr>
          <p:cNvSpPr/>
          <p:nvPr/>
        </p:nvSpPr>
        <p:spPr>
          <a:xfrm>
            <a:off x="7184879" y="2225134"/>
            <a:ext cx="1226643" cy="65350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12821F45-C935-CF4D-A9DC-BA3F7F091DD3}"/>
              </a:ext>
            </a:extLst>
          </p:cNvPr>
          <p:cNvSpPr txBox="1"/>
          <p:nvPr/>
        </p:nvSpPr>
        <p:spPr>
          <a:xfrm>
            <a:off x="7630258" y="2734262"/>
            <a:ext cx="2844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9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CN" altLang="en-US" sz="9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007625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5AC6703E-3D94-4C61-A101-D2BA49595C7D}"/>
              </a:ext>
            </a:extLst>
          </p:cNvPr>
          <p:cNvGrpSpPr/>
          <p:nvPr/>
        </p:nvGrpSpPr>
        <p:grpSpPr>
          <a:xfrm>
            <a:off x="1494843" y="1231723"/>
            <a:ext cx="6223229" cy="3475744"/>
            <a:chOff x="0" y="38100"/>
            <a:chExt cx="5295900" cy="3152775"/>
          </a:xfrm>
        </p:grpSpPr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71E99D3F-1F8F-41F6-B633-769EE963009D}"/>
                </a:ext>
              </a:extLst>
            </p:cNvPr>
            <p:cNvGrpSpPr/>
            <p:nvPr/>
          </p:nvGrpSpPr>
          <p:grpSpPr>
            <a:xfrm>
              <a:off x="0" y="295275"/>
              <a:ext cx="5295900" cy="2895600"/>
              <a:chOff x="0" y="0"/>
              <a:chExt cx="5295900" cy="2895600"/>
            </a:xfrm>
          </p:grpSpPr>
          <p:grpSp>
            <p:nvGrpSpPr>
              <p:cNvPr id="5" name="组合 4">
                <a:extLst>
                  <a:ext uri="{FF2B5EF4-FFF2-40B4-BE49-F238E27FC236}">
                    <a16:creationId xmlns:a16="http://schemas.microsoft.com/office/drawing/2014/main" id="{5BAE27BD-C487-44BF-8F97-4055FAB78357}"/>
                  </a:ext>
                </a:extLst>
              </p:cNvPr>
              <p:cNvGrpSpPr/>
              <p:nvPr/>
            </p:nvGrpSpPr>
            <p:grpSpPr>
              <a:xfrm>
                <a:off x="0" y="0"/>
                <a:ext cx="5295900" cy="2848610"/>
                <a:chOff x="0" y="0"/>
                <a:chExt cx="5295900" cy="2848610"/>
              </a:xfrm>
            </p:grpSpPr>
            <p:pic>
              <p:nvPicPr>
                <p:cNvPr id="7" name="图片 6">
                  <a:extLst>
                    <a:ext uri="{FF2B5EF4-FFF2-40B4-BE49-F238E27FC236}">
                      <a16:creationId xmlns:a16="http://schemas.microsoft.com/office/drawing/2014/main" id="{1352D84A-4112-45E0-AB5E-8E38E566AF4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33375" y="9525"/>
                  <a:ext cx="4962525" cy="2839085"/>
                </a:xfrm>
                <a:prstGeom prst="rect">
                  <a:avLst/>
                </a:prstGeom>
              </p:spPr>
            </p:pic>
            <p:sp>
              <p:nvSpPr>
                <p:cNvPr id="8" name="文本框 2">
                  <a:extLst>
                    <a:ext uri="{FF2B5EF4-FFF2-40B4-BE49-F238E27FC236}">
                      <a16:creationId xmlns:a16="http://schemas.microsoft.com/office/drawing/2014/main" id="{80910F58-2578-4FC7-A1BE-6482BA618F8F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-1157287" y="1157287"/>
                  <a:ext cx="2609850" cy="2952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n-US" sz="1200" kern="100" dirty="0">
                      <a:effectLst/>
                      <a:latin typeface="Arial" panose="020B0604020202020204" pitchFamily="34" charset="0"/>
                      <a:ea typeface="等线" panose="02010600030101010101" pitchFamily="2" charset="-122"/>
                      <a:cs typeface="Times New Roman" panose="02020603050405020304" pitchFamily="18" charset="0"/>
                    </a:rPr>
                    <a:t>Rank of Distance (bray-</a:t>
                  </a:r>
                  <a:r>
                    <a:rPr lang="en-US" sz="1200" kern="100" dirty="0" err="1">
                      <a:effectLst/>
                      <a:latin typeface="Arial" panose="020B0604020202020204" pitchFamily="34" charset="0"/>
                      <a:ea typeface="等线" panose="02010600030101010101" pitchFamily="2" charset="-122"/>
                      <a:cs typeface="Times New Roman" panose="02020603050405020304" pitchFamily="18" charset="0"/>
                    </a:rPr>
                    <a:t>curtis</a:t>
                  </a:r>
                  <a:r>
                    <a:rPr lang="en-US" sz="1200" kern="100" dirty="0">
                      <a:effectLst/>
                      <a:latin typeface="Arial" panose="020B0604020202020204" pitchFamily="34" charset="0"/>
                      <a:ea typeface="等线" panose="02010600030101010101" pitchFamily="2" charset="-122"/>
                      <a:cs typeface="Times New Roman" panose="02020603050405020304" pitchFamily="18" charset="0"/>
                    </a:rPr>
                    <a:t>)</a:t>
                  </a:r>
                  <a:endParaRPr lang="zh-CN" sz="1200" kern="100" dirty="0">
                    <a:effectLst/>
                    <a:latin typeface="等线" panose="02010600030101010101" pitchFamily="2" charset="-122"/>
                    <a:ea typeface="等线" panose="02010600030101010101" pitchFamily="2" charset="-122"/>
                    <a:cs typeface="Times New Roman" panose="02020603050405020304" pitchFamily="18" charset="0"/>
                  </a:endParaRPr>
                </a:p>
                <a:p>
                  <a:pPr algn="just">
                    <a:spcAft>
                      <a:spcPts val="0"/>
                    </a:spcAft>
                  </a:pPr>
                  <a:r>
                    <a:rPr lang="en-US" sz="1200" kern="100" dirty="0">
                      <a:effectLst/>
                      <a:latin typeface="等线" panose="02010600030101010101" pitchFamily="2" charset="-122"/>
                      <a:ea typeface="等线" panose="02010600030101010101" pitchFamily="2" charset="-122"/>
                      <a:cs typeface="Times New Roman" panose="02020603050405020304" pitchFamily="18" charset="0"/>
                    </a:rPr>
                    <a:t> </a:t>
                  </a:r>
                  <a:endParaRPr lang="zh-CN" sz="1200" kern="100" dirty="0">
                    <a:effectLst/>
                    <a:latin typeface="等线" panose="02010600030101010101" pitchFamily="2" charset="-122"/>
                    <a:ea typeface="等线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6" name="文本框 2">
                <a:extLst>
                  <a:ext uri="{FF2B5EF4-FFF2-40B4-BE49-F238E27FC236}">
                    <a16:creationId xmlns:a16="http://schemas.microsoft.com/office/drawing/2014/main" id="{9BE17A53-25CB-47E3-8FA4-589E40EADD8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47674" y="2581275"/>
                <a:ext cx="4821160" cy="314325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 indent="466725" algn="just">
                  <a:spcAft>
                    <a:spcPts val="0"/>
                  </a:spcAft>
                </a:pPr>
                <a:r>
                  <a:rPr lang="en-US" sz="1050" kern="10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Between           PAR               STR             TAR</a:t>
                </a:r>
                <a:endParaRPr lang="zh-CN" sz="1050" kern="100">
                  <a:effectLst/>
                  <a:latin typeface="等线" panose="02010600030101010101" pitchFamily="2" charset="-122"/>
                  <a:ea typeface="等线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" name="文本框 2">
              <a:extLst>
                <a:ext uri="{FF2B5EF4-FFF2-40B4-BE49-F238E27FC236}">
                  <a16:creationId xmlns:a16="http://schemas.microsoft.com/office/drawing/2014/main" id="{DBA21FCE-2CD7-44F4-948B-72DD35B7A33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8650" y="38100"/>
              <a:ext cx="4400550" cy="295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050" kern="100"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R=0.975            P=0.006</a:t>
              </a:r>
              <a:endParaRPr lang="zh-CN" sz="1050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just">
                <a:spcAft>
                  <a:spcPts val="0"/>
                </a:spcAft>
              </a:pPr>
              <a:r>
                <a:rPr lang="en-US" sz="1050" kern="100">
                  <a:effectLst/>
                  <a:latin typeface="等线" panose="02010600030101010101" pitchFamily="2" charset="-122"/>
                  <a:ea typeface="等线" panose="02010600030101010101" pitchFamily="2" charset="-122"/>
                  <a:cs typeface="Times New Roman" panose="02020603050405020304" pitchFamily="18" charset="0"/>
                </a:rPr>
                <a:t> </a:t>
              </a:r>
              <a:endParaRPr lang="zh-CN" sz="1050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sp>
        <p:nvSpPr>
          <p:cNvPr id="9" name="文本框 2">
            <a:extLst>
              <a:ext uri="{FF2B5EF4-FFF2-40B4-BE49-F238E27FC236}">
                <a16:creationId xmlns:a16="http://schemas.microsoft.com/office/drawing/2014/main" id="{CE7FD321-25E4-4FE2-B587-9E783C164B4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83972" y="5019498"/>
            <a:ext cx="6134100" cy="3465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Fig.S2</a:t>
            </a:r>
            <a:r>
              <a:rPr lang="en-US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Comparison of differences between groups is shown by </a:t>
            </a:r>
            <a:r>
              <a:rPr lang="en-US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OSIM</a:t>
            </a:r>
            <a:r>
              <a:rPr lang="en-US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. Distance calculated on OUT level of each sample groups.</a:t>
            </a:r>
            <a:endParaRPr 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05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 </a:t>
            </a:r>
            <a:endParaRPr lang="zh-CN" sz="105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216002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443</TotalTime>
  <Words>860</Words>
  <Application>Microsoft Macintosh PowerPoint</Application>
  <PresentationFormat>全屏显示(4:3)</PresentationFormat>
  <Paragraphs>225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4" baseType="lpstr">
      <vt:lpstr>DengXian</vt:lpstr>
      <vt:lpstr>DengXian</vt:lpstr>
      <vt:lpstr>等线 Light</vt:lpstr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包智华</dc:creator>
  <cp:lastModifiedBy>包智华</cp:lastModifiedBy>
  <cp:revision>114</cp:revision>
  <dcterms:created xsi:type="dcterms:W3CDTF">2019-11-26T14:47:58Z</dcterms:created>
  <dcterms:modified xsi:type="dcterms:W3CDTF">2020-02-26T15:35:31Z</dcterms:modified>
</cp:coreProperties>
</file>